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3"/>
    <p:restoredTop sz="94628"/>
  </p:normalViewPr>
  <p:slideViewPr>
    <p:cSldViewPr snapToGrid="0">
      <p:cViewPr varScale="1">
        <p:scale>
          <a:sx n="115" d="100"/>
          <a:sy n="115" d="100"/>
        </p:scale>
        <p:origin x="164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11083-A277-2340-A9B4-2F2AEEF5429E}" type="datetimeFigureOut">
              <a:rPr kumimoji="1" lang="ja-US" altLang="en-US" smtClean="0"/>
              <a:t>2/20/25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F58BE-DA4F-2F46-B1A8-9842F6EE658D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990059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11083-A277-2340-A9B4-2F2AEEF5429E}" type="datetimeFigureOut">
              <a:rPr kumimoji="1" lang="ja-US" altLang="en-US" smtClean="0"/>
              <a:t>2/20/25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F58BE-DA4F-2F46-B1A8-9842F6EE658D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4195563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11083-A277-2340-A9B4-2F2AEEF5429E}" type="datetimeFigureOut">
              <a:rPr kumimoji="1" lang="ja-US" altLang="en-US" smtClean="0"/>
              <a:t>2/20/25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F58BE-DA4F-2F46-B1A8-9842F6EE658D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4101520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11083-A277-2340-A9B4-2F2AEEF5429E}" type="datetimeFigureOut">
              <a:rPr kumimoji="1" lang="ja-US" altLang="en-US" smtClean="0"/>
              <a:t>2/20/25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F58BE-DA4F-2F46-B1A8-9842F6EE658D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1883432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11083-A277-2340-A9B4-2F2AEEF5429E}" type="datetimeFigureOut">
              <a:rPr kumimoji="1" lang="ja-US" altLang="en-US" smtClean="0"/>
              <a:t>2/20/25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F58BE-DA4F-2F46-B1A8-9842F6EE658D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699154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11083-A277-2340-A9B4-2F2AEEF5429E}" type="datetimeFigureOut">
              <a:rPr kumimoji="1" lang="ja-US" altLang="en-US" smtClean="0"/>
              <a:t>2/20/25</a:t>
            </a:fld>
            <a:endParaRPr kumimoji="1" lang="ja-US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F58BE-DA4F-2F46-B1A8-9842F6EE658D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1656613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11083-A277-2340-A9B4-2F2AEEF5429E}" type="datetimeFigureOut">
              <a:rPr kumimoji="1" lang="ja-US" altLang="en-US" smtClean="0"/>
              <a:t>2/20/25</a:t>
            </a:fld>
            <a:endParaRPr kumimoji="1" lang="ja-US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F58BE-DA4F-2F46-B1A8-9842F6EE658D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486960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11083-A277-2340-A9B4-2F2AEEF5429E}" type="datetimeFigureOut">
              <a:rPr kumimoji="1" lang="ja-US" altLang="en-US" smtClean="0"/>
              <a:t>2/20/25</a:t>
            </a:fld>
            <a:endParaRPr kumimoji="1" lang="ja-US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F58BE-DA4F-2F46-B1A8-9842F6EE658D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548957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11083-A277-2340-A9B4-2F2AEEF5429E}" type="datetimeFigureOut">
              <a:rPr kumimoji="1" lang="ja-US" altLang="en-US" smtClean="0"/>
              <a:t>2/20/25</a:t>
            </a:fld>
            <a:endParaRPr kumimoji="1" lang="ja-US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F58BE-DA4F-2F46-B1A8-9842F6EE658D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4145732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11083-A277-2340-A9B4-2F2AEEF5429E}" type="datetimeFigureOut">
              <a:rPr kumimoji="1" lang="ja-US" altLang="en-US" smtClean="0"/>
              <a:t>2/20/25</a:t>
            </a:fld>
            <a:endParaRPr kumimoji="1" lang="ja-US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F58BE-DA4F-2F46-B1A8-9842F6EE658D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14049921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011083-A277-2340-A9B4-2F2AEEF5429E}" type="datetimeFigureOut">
              <a:rPr kumimoji="1" lang="ja-US" altLang="en-US" smtClean="0"/>
              <a:t>2/20/25</a:t>
            </a:fld>
            <a:endParaRPr kumimoji="1" lang="ja-US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F58BE-DA4F-2F46-B1A8-9842F6EE658D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886462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A011083-A277-2340-A9B4-2F2AEEF5429E}" type="datetimeFigureOut">
              <a:rPr kumimoji="1" lang="ja-US" altLang="en-US" smtClean="0"/>
              <a:t>2/20/25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9F58BE-DA4F-2F46-B1A8-9842F6EE658D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15532535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A6F1F6D-4E4D-F91F-E321-BBE4B7F38C54}"/>
              </a:ext>
            </a:extLst>
          </p:cNvPr>
          <p:cNvSpPr txBox="1"/>
          <p:nvPr/>
        </p:nvSpPr>
        <p:spPr>
          <a:xfrm>
            <a:off x="836724" y="4241577"/>
            <a:ext cx="730366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1. Silhouette analyses of loneliness orientation clusters</a:t>
            </a:r>
          </a:p>
          <a:p>
            <a:r>
              <a:rPr kumimoji="1" lang="en-US" altLang="ja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indicates a silhouette of 3-clusters,  and b) indicates a silhouette of 4-clusters. Negative values suggest that the classification may be incorrect.</a:t>
            </a:r>
          </a:p>
        </p:txBody>
      </p:sp>
      <p:pic>
        <p:nvPicPr>
          <p:cNvPr id="8" name="図 7" descr="グラフ, ヒストグラム&#10;&#10;自動的に生成された説明">
            <a:extLst>
              <a:ext uri="{FF2B5EF4-FFF2-40B4-BE49-F238E27FC236}">
                <a16:creationId xmlns:a16="http://schemas.microsoft.com/office/drawing/2014/main" id="{B14E4EB5-3039-2ED7-E937-9CE82D50C1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6784" y="888194"/>
            <a:ext cx="4067113" cy="3053121"/>
          </a:xfrm>
          <a:prstGeom prst="rect">
            <a:avLst/>
          </a:prstGeom>
        </p:spPr>
      </p:pic>
      <p:pic>
        <p:nvPicPr>
          <p:cNvPr id="10" name="図 9" descr="グラフ&#10;&#10;自動的に生成された説明">
            <a:extLst>
              <a:ext uri="{FF2B5EF4-FFF2-40B4-BE49-F238E27FC236}">
                <a16:creationId xmlns:a16="http://schemas.microsoft.com/office/drawing/2014/main" id="{43EC1D20-CEFD-024B-A339-6C45F2017B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47024" y="921750"/>
            <a:ext cx="4067114" cy="3053121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B705806-F83A-C92F-030E-EB78B246903D}"/>
              </a:ext>
            </a:extLst>
          </p:cNvPr>
          <p:cNvSpPr txBox="1"/>
          <p:nvPr/>
        </p:nvSpPr>
        <p:spPr>
          <a:xfrm>
            <a:off x="483116" y="838582"/>
            <a:ext cx="32733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350" dirty="0"/>
              <a:t>a)</a:t>
            </a:r>
            <a:endParaRPr kumimoji="1" lang="ja-US" altLang="en-US" sz="135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2641D63-B769-C13F-2EC1-71EEE250D961}"/>
              </a:ext>
            </a:extLst>
          </p:cNvPr>
          <p:cNvSpPr txBox="1"/>
          <p:nvPr/>
        </p:nvSpPr>
        <p:spPr>
          <a:xfrm>
            <a:off x="4380151" y="888194"/>
            <a:ext cx="3337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350" dirty="0"/>
              <a:t>b)</a:t>
            </a:r>
            <a:endParaRPr kumimoji="1" lang="ja-US" altLang="en-US" sz="1350" dirty="0"/>
          </a:p>
        </p:txBody>
      </p:sp>
    </p:spTree>
    <p:extLst>
      <p:ext uri="{BB962C8B-B14F-4D97-AF65-F5344CB8AC3E}">
        <p14:creationId xmlns:p14="http://schemas.microsoft.com/office/powerpoint/2010/main" val="905969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58</TotalTime>
  <Words>40</Words>
  <Application>Microsoft Macintosh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岡島　義</dc:creator>
  <cp:lastModifiedBy>岡島　義</cp:lastModifiedBy>
  <cp:revision>7</cp:revision>
  <dcterms:created xsi:type="dcterms:W3CDTF">2025-02-14T03:53:45Z</dcterms:created>
  <dcterms:modified xsi:type="dcterms:W3CDTF">2025-02-20T08:38:20Z</dcterms:modified>
</cp:coreProperties>
</file>